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74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887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436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083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19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831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517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87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719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098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050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887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86B2-6CD2-4C56-B2CE-4788506B7042}" type="datetimeFigureOut">
              <a:rPr lang="en-US" smtClean="0"/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C2121-47CC-4111-AF5E-C612F426F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48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14400" y="4190998"/>
            <a:ext cx="1295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BMI</a:t>
            </a:r>
            <a:endParaRPr lang="en-US" sz="2400" dirty="0"/>
          </a:p>
        </p:txBody>
      </p:sp>
      <p:sp>
        <p:nvSpPr>
          <p:cNvPr id="5" name="TextBox 4"/>
          <p:cNvSpPr txBox="1"/>
          <p:nvPr/>
        </p:nvSpPr>
        <p:spPr>
          <a:xfrm>
            <a:off x="3657600" y="4006333"/>
            <a:ext cx="1295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Skeletal muscle</a:t>
            </a:r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3657600" y="3048000"/>
            <a:ext cx="14234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Adiposity</a:t>
            </a:r>
            <a:endParaRPr 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6353556" y="4191000"/>
            <a:ext cx="1295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Death</a:t>
            </a:r>
            <a:endParaRPr lang="en-US" sz="2400" dirty="0"/>
          </a:p>
        </p:txBody>
      </p:sp>
      <p:grpSp>
        <p:nvGrpSpPr>
          <p:cNvPr id="10" name="Group 9"/>
          <p:cNvGrpSpPr/>
          <p:nvPr/>
        </p:nvGrpSpPr>
        <p:grpSpPr>
          <a:xfrm>
            <a:off x="2278380" y="1066800"/>
            <a:ext cx="4503420" cy="923330"/>
            <a:chOff x="2407920" y="1066800"/>
            <a:chExt cx="4503420" cy="923330"/>
          </a:xfrm>
        </p:grpSpPr>
        <p:sp>
          <p:nvSpPr>
            <p:cNvPr id="8" name="TextBox 7"/>
            <p:cNvSpPr txBox="1"/>
            <p:nvPr/>
          </p:nvSpPr>
          <p:spPr>
            <a:xfrm>
              <a:off x="2407920" y="1066800"/>
              <a:ext cx="2057400" cy="9233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numCol="1" rtlCol="0">
              <a:spAutoFit/>
            </a:bodyPr>
            <a:lstStyle/>
            <a:p>
              <a:r>
                <a:rPr lang="en-US" dirty="0" smtClean="0"/>
                <a:t>Age</a:t>
              </a:r>
            </a:p>
            <a:p>
              <a:r>
                <a:rPr lang="en-US" dirty="0" smtClean="0"/>
                <a:t>Sex</a:t>
              </a:r>
            </a:p>
            <a:p>
              <a:r>
                <a:rPr lang="en-US" dirty="0" smtClean="0"/>
                <a:t>Race/ethnicity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465320" y="1066800"/>
              <a:ext cx="2446020" cy="9233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numCol="1" rtlCol="0">
              <a:spAutoFit/>
            </a:bodyPr>
            <a:lstStyle/>
            <a:p>
              <a:r>
                <a:rPr lang="en-US" dirty="0" smtClean="0"/>
                <a:t>Socioeconomic status</a:t>
              </a:r>
            </a:p>
            <a:p>
              <a:r>
                <a:rPr lang="en-US" dirty="0" smtClean="0"/>
                <a:t>Smoking</a:t>
              </a:r>
            </a:p>
            <a:p>
              <a:r>
                <a:rPr lang="en-US" dirty="0" smtClean="0"/>
                <a:t>Physical activity</a:t>
              </a:r>
              <a:endParaRPr lang="en-US" dirty="0"/>
            </a:p>
          </p:txBody>
        </p:sp>
      </p:grpSp>
      <p:cxnSp>
        <p:nvCxnSpPr>
          <p:cNvPr id="12" name="Straight Arrow Connector 11"/>
          <p:cNvCxnSpPr>
            <a:stCxn id="4" idx="3"/>
            <a:endCxn id="5" idx="1"/>
          </p:cNvCxnSpPr>
          <p:nvPr/>
        </p:nvCxnSpPr>
        <p:spPr>
          <a:xfrm>
            <a:off x="2209800" y="4421831"/>
            <a:ext cx="1447800" cy="1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4964430" y="4421832"/>
            <a:ext cx="1447800" cy="1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V="1">
            <a:off x="2209800" y="3509665"/>
            <a:ext cx="1420368" cy="681336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5081016" y="3509665"/>
            <a:ext cx="1331214" cy="68133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6117336" y="2209800"/>
            <a:ext cx="664464" cy="179653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2057400" y="2209800"/>
            <a:ext cx="862584" cy="179653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6008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3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Abramowitz</dc:creator>
  <cp:lastModifiedBy>Matthew Abramowitz</cp:lastModifiedBy>
  <cp:revision>2</cp:revision>
  <dcterms:created xsi:type="dcterms:W3CDTF">2017-08-28T01:30:11Z</dcterms:created>
  <dcterms:modified xsi:type="dcterms:W3CDTF">2018-03-12T19:22:20Z</dcterms:modified>
</cp:coreProperties>
</file>